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98969-056B-4E08-9287-04F0529BB5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B0EE2-4A30-4610-93C0-42DC45F2B2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9815C-C271-4856-B697-7944CA9F38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0806FD-1E3A-4E43-9E5A-51A113B038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76480-7140-49DB-8717-29515F3BF6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6233A6-383F-44D9-957D-033FFE241F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C36DC-1637-446C-B758-E16DD75A73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11D800-0E6A-42B1-931B-E54099115B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82C690-7C3C-4BC8-96CB-D716AB85A0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7A5D9-F78E-4165-829E-C7BA1100D5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943F85-0642-4C9B-AA6F-4AD5048299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BE752-579F-4C03-8A54-7642B1C19B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BBD947-FB0E-48CA-AF41-AD562760832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www.jmir.org/2003/2" TargetMode="External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600200" y="1447920"/>
            <a:ext cx="6035760" cy="33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ultimedia appendix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evelopment and Evaluation of the Virtual Pathology Slide: A New Tool in Telepatholog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J Med Internet Res 200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Vol. 5 / Iss. 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 u="sng">
                <a:solidFill>
                  <a:srgbClr val="009999"/>
                </a:solidFill>
                <a:uFillTx/>
                <a:latin typeface="Arial"/>
                <a:hlinkClick r:id="rId1"/>
              </a:rPr>
              <a:t>http://www.jmir.org/2003/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ese slides show screenshots of the Virtual Pathology Web browse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9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9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9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9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9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9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06-09T18:30:14Z</dcterms:created>
  <dc:creator>Gunther Eysenbach</dc:creator>
  <dc:description/>
  <dc:language>en-US</dc:language>
  <cp:lastModifiedBy>Gunther Eysenbach</cp:lastModifiedBy>
  <dcterms:modified xsi:type="dcterms:W3CDTF">2003-06-09T20:18:59Z</dcterms:modified>
  <cp:revision>2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1287861172</vt:r8>
  </property>
  <property fmtid="{D5CDD505-2E9C-101B-9397-08002B2CF9AE}" pid="3" name="_AuthorEmail">
    <vt:lpwstr>geysenba@uhnres.utoronto.ca</vt:lpwstr>
  </property>
  <property fmtid="{D5CDD505-2E9C-101B-9397-08002B2CF9AE}" pid="4" name="_AuthorEmailDisplayName">
    <vt:lpwstr>Dr. Gunther Eysenbach</vt:lpwstr>
  </property>
  <property fmtid="{D5CDD505-2E9C-101B-9397-08002B2CF9AE}" pid="5" name="_EmailSubject">
    <vt:lpwstr>2003031001</vt:lpwstr>
  </property>
</Properties>
</file>